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</p:sldIdLst>
  <p:sldSz cx="7534275" cy="106441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1" autoAdjust="0"/>
    <p:restoredTop sz="94660"/>
  </p:normalViewPr>
  <p:slideViewPr>
    <p:cSldViewPr snapToGrid="0">
      <p:cViewPr>
        <p:scale>
          <a:sx n="70" d="100"/>
          <a:sy n="70" d="100"/>
        </p:scale>
        <p:origin x="25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5071" y="1742001"/>
            <a:ext cx="6404134" cy="3705754"/>
          </a:xfrm>
        </p:spPr>
        <p:txBody>
          <a:bodyPr anchor="b"/>
          <a:lstStyle>
            <a:lvl1pPr algn="ctr">
              <a:defRPr sz="49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1785" y="5590663"/>
            <a:ext cx="5650706" cy="2569881"/>
          </a:xfrm>
        </p:spPr>
        <p:txBody>
          <a:bodyPr/>
          <a:lstStyle>
            <a:lvl1pPr marL="0" indent="0" algn="ctr">
              <a:buNone/>
              <a:defRPr sz="1978"/>
            </a:lvl1pPr>
            <a:lvl2pPr marL="376733" indent="0" algn="ctr">
              <a:buNone/>
              <a:defRPr sz="1648"/>
            </a:lvl2pPr>
            <a:lvl3pPr marL="753466" indent="0" algn="ctr">
              <a:buNone/>
              <a:defRPr sz="1483"/>
            </a:lvl3pPr>
            <a:lvl4pPr marL="1130198" indent="0" algn="ctr">
              <a:buNone/>
              <a:defRPr sz="1318"/>
            </a:lvl4pPr>
            <a:lvl5pPr marL="1506931" indent="0" algn="ctr">
              <a:buNone/>
              <a:defRPr sz="1318"/>
            </a:lvl5pPr>
            <a:lvl6pPr marL="1883664" indent="0" algn="ctr">
              <a:buNone/>
              <a:defRPr sz="1318"/>
            </a:lvl6pPr>
            <a:lvl7pPr marL="2260397" indent="0" algn="ctr">
              <a:buNone/>
              <a:defRPr sz="1318"/>
            </a:lvl7pPr>
            <a:lvl8pPr marL="2637130" indent="0" algn="ctr">
              <a:buNone/>
              <a:defRPr sz="1318"/>
            </a:lvl8pPr>
            <a:lvl9pPr marL="3013862" indent="0" algn="ctr">
              <a:buNone/>
              <a:defRPr sz="131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917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363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91716" y="566705"/>
            <a:ext cx="1624578" cy="902045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7982" y="566705"/>
            <a:ext cx="4779556" cy="902045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661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73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4058" y="2653658"/>
            <a:ext cx="6498312" cy="4427686"/>
          </a:xfrm>
        </p:spPr>
        <p:txBody>
          <a:bodyPr anchor="b"/>
          <a:lstStyle>
            <a:lvl1pPr>
              <a:defRPr sz="49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4058" y="7123232"/>
            <a:ext cx="6498312" cy="2328415"/>
          </a:xfrm>
        </p:spPr>
        <p:txBody>
          <a:bodyPr/>
          <a:lstStyle>
            <a:lvl1pPr marL="0" indent="0">
              <a:buNone/>
              <a:defRPr sz="1978">
                <a:solidFill>
                  <a:schemeClr val="tx1"/>
                </a:solidFill>
              </a:defRPr>
            </a:lvl1pPr>
            <a:lvl2pPr marL="376733" indent="0">
              <a:buNone/>
              <a:defRPr sz="1648">
                <a:solidFill>
                  <a:schemeClr val="tx1">
                    <a:tint val="75000"/>
                  </a:schemeClr>
                </a:solidFill>
              </a:defRPr>
            </a:lvl2pPr>
            <a:lvl3pPr marL="753466" indent="0">
              <a:buNone/>
              <a:defRPr sz="1483">
                <a:solidFill>
                  <a:schemeClr val="tx1">
                    <a:tint val="75000"/>
                  </a:schemeClr>
                </a:solidFill>
              </a:defRPr>
            </a:lvl3pPr>
            <a:lvl4pPr marL="1130198" indent="0">
              <a:buNone/>
              <a:defRPr sz="1318">
                <a:solidFill>
                  <a:schemeClr val="tx1">
                    <a:tint val="75000"/>
                  </a:schemeClr>
                </a:solidFill>
              </a:defRPr>
            </a:lvl4pPr>
            <a:lvl5pPr marL="1506931" indent="0">
              <a:buNone/>
              <a:defRPr sz="1318">
                <a:solidFill>
                  <a:schemeClr val="tx1">
                    <a:tint val="75000"/>
                  </a:schemeClr>
                </a:solidFill>
              </a:defRPr>
            </a:lvl5pPr>
            <a:lvl6pPr marL="1883664" indent="0">
              <a:buNone/>
              <a:defRPr sz="1318">
                <a:solidFill>
                  <a:schemeClr val="tx1">
                    <a:tint val="75000"/>
                  </a:schemeClr>
                </a:solidFill>
              </a:defRPr>
            </a:lvl6pPr>
            <a:lvl7pPr marL="2260397" indent="0">
              <a:buNone/>
              <a:defRPr sz="1318">
                <a:solidFill>
                  <a:schemeClr val="tx1">
                    <a:tint val="75000"/>
                  </a:schemeClr>
                </a:solidFill>
              </a:defRPr>
            </a:lvl7pPr>
            <a:lvl8pPr marL="2637130" indent="0">
              <a:buNone/>
              <a:defRPr sz="1318">
                <a:solidFill>
                  <a:schemeClr val="tx1">
                    <a:tint val="75000"/>
                  </a:schemeClr>
                </a:solidFill>
              </a:defRPr>
            </a:lvl8pPr>
            <a:lvl9pPr marL="3013862" indent="0">
              <a:buNone/>
              <a:defRPr sz="131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203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7981" y="2833522"/>
            <a:ext cx="3202067" cy="67536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14227" y="2833522"/>
            <a:ext cx="3202067" cy="67536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358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8963" y="566707"/>
            <a:ext cx="6498312" cy="2057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8964" y="2609305"/>
            <a:ext cx="3187351" cy="1278780"/>
          </a:xfrm>
        </p:spPr>
        <p:txBody>
          <a:bodyPr anchor="b"/>
          <a:lstStyle>
            <a:lvl1pPr marL="0" indent="0">
              <a:buNone/>
              <a:defRPr sz="1978" b="1"/>
            </a:lvl1pPr>
            <a:lvl2pPr marL="376733" indent="0">
              <a:buNone/>
              <a:defRPr sz="1648" b="1"/>
            </a:lvl2pPr>
            <a:lvl3pPr marL="753466" indent="0">
              <a:buNone/>
              <a:defRPr sz="1483" b="1"/>
            </a:lvl3pPr>
            <a:lvl4pPr marL="1130198" indent="0">
              <a:buNone/>
              <a:defRPr sz="1318" b="1"/>
            </a:lvl4pPr>
            <a:lvl5pPr marL="1506931" indent="0">
              <a:buNone/>
              <a:defRPr sz="1318" b="1"/>
            </a:lvl5pPr>
            <a:lvl6pPr marL="1883664" indent="0">
              <a:buNone/>
              <a:defRPr sz="1318" b="1"/>
            </a:lvl6pPr>
            <a:lvl7pPr marL="2260397" indent="0">
              <a:buNone/>
              <a:defRPr sz="1318" b="1"/>
            </a:lvl7pPr>
            <a:lvl8pPr marL="2637130" indent="0">
              <a:buNone/>
              <a:defRPr sz="1318" b="1"/>
            </a:lvl8pPr>
            <a:lvl9pPr marL="3013862" indent="0">
              <a:buNone/>
              <a:defRPr sz="131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8964" y="3888085"/>
            <a:ext cx="3187351" cy="57187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14227" y="2609305"/>
            <a:ext cx="3203048" cy="1278780"/>
          </a:xfrm>
        </p:spPr>
        <p:txBody>
          <a:bodyPr anchor="b"/>
          <a:lstStyle>
            <a:lvl1pPr marL="0" indent="0">
              <a:buNone/>
              <a:defRPr sz="1978" b="1"/>
            </a:lvl1pPr>
            <a:lvl2pPr marL="376733" indent="0">
              <a:buNone/>
              <a:defRPr sz="1648" b="1"/>
            </a:lvl2pPr>
            <a:lvl3pPr marL="753466" indent="0">
              <a:buNone/>
              <a:defRPr sz="1483" b="1"/>
            </a:lvl3pPr>
            <a:lvl4pPr marL="1130198" indent="0">
              <a:buNone/>
              <a:defRPr sz="1318" b="1"/>
            </a:lvl4pPr>
            <a:lvl5pPr marL="1506931" indent="0">
              <a:buNone/>
              <a:defRPr sz="1318" b="1"/>
            </a:lvl5pPr>
            <a:lvl6pPr marL="1883664" indent="0">
              <a:buNone/>
              <a:defRPr sz="1318" b="1"/>
            </a:lvl6pPr>
            <a:lvl7pPr marL="2260397" indent="0">
              <a:buNone/>
              <a:defRPr sz="1318" b="1"/>
            </a:lvl7pPr>
            <a:lvl8pPr marL="2637130" indent="0">
              <a:buNone/>
              <a:defRPr sz="1318" b="1"/>
            </a:lvl8pPr>
            <a:lvl9pPr marL="3013862" indent="0">
              <a:buNone/>
              <a:defRPr sz="131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14227" y="3888085"/>
            <a:ext cx="3203048" cy="57187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11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524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507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8963" y="709612"/>
            <a:ext cx="2430000" cy="2483644"/>
          </a:xfrm>
        </p:spPr>
        <p:txBody>
          <a:bodyPr anchor="b"/>
          <a:lstStyle>
            <a:lvl1pPr>
              <a:defRPr sz="263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03048" y="1532569"/>
            <a:ext cx="3814227" cy="7564272"/>
          </a:xfrm>
        </p:spPr>
        <p:txBody>
          <a:bodyPr/>
          <a:lstStyle>
            <a:lvl1pPr>
              <a:defRPr sz="2637"/>
            </a:lvl1pPr>
            <a:lvl2pPr>
              <a:defRPr sz="2307"/>
            </a:lvl2pPr>
            <a:lvl3pPr>
              <a:defRPr sz="1978"/>
            </a:lvl3pPr>
            <a:lvl4pPr>
              <a:defRPr sz="1648"/>
            </a:lvl4pPr>
            <a:lvl5pPr>
              <a:defRPr sz="1648"/>
            </a:lvl5pPr>
            <a:lvl6pPr>
              <a:defRPr sz="1648"/>
            </a:lvl6pPr>
            <a:lvl7pPr>
              <a:defRPr sz="1648"/>
            </a:lvl7pPr>
            <a:lvl8pPr>
              <a:defRPr sz="1648"/>
            </a:lvl8pPr>
            <a:lvl9pPr>
              <a:defRPr sz="164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8963" y="3193257"/>
            <a:ext cx="2430000" cy="5915902"/>
          </a:xfrm>
        </p:spPr>
        <p:txBody>
          <a:bodyPr/>
          <a:lstStyle>
            <a:lvl1pPr marL="0" indent="0">
              <a:buNone/>
              <a:defRPr sz="1318"/>
            </a:lvl1pPr>
            <a:lvl2pPr marL="376733" indent="0">
              <a:buNone/>
              <a:defRPr sz="1154"/>
            </a:lvl2pPr>
            <a:lvl3pPr marL="753466" indent="0">
              <a:buNone/>
              <a:defRPr sz="989"/>
            </a:lvl3pPr>
            <a:lvl4pPr marL="1130198" indent="0">
              <a:buNone/>
              <a:defRPr sz="824"/>
            </a:lvl4pPr>
            <a:lvl5pPr marL="1506931" indent="0">
              <a:buNone/>
              <a:defRPr sz="824"/>
            </a:lvl5pPr>
            <a:lvl6pPr marL="1883664" indent="0">
              <a:buNone/>
              <a:defRPr sz="824"/>
            </a:lvl6pPr>
            <a:lvl7pPr marL="2260397" indent="0">
              <a:buNone/>
              <a:defRPr sz="824"/>
            </a:lvl7pPr>
            <a:lvl8pPr marL="2637130" indent="0">
              <a:buNone/>
              <a:defRPr sz="824"/>
            </a:lvl8pPr>
            <a:lvl9pPr marL="3013862" indent="0">
              <a:buNone/>
              <a:defRPr sz="82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872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8963" y="709612"/>
            <a:ext cx="2430000" cy="2483644"/>
          </a:xfrm>
        </p:spPr>
        <p:txBody>
          <a:bodyPr anchor="b"/>
          <a:lstStyle>
            <a:lvl1pPr>
              <a:defRPr sz="263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03048" y="1532569"/>
            <a:ext cx="3814227" cy="7564272"/>
          </a:xfrm>
        </p:spPr>
        <p:txBody>
          <a:bodyPr anchor="t"/>
          <a:lstStyle>
            <a:lvl1pPr marL="0" indent="0">
              <a:buNone/>
              <a:defRPr sz="2637"/>
            </a:lvl1pPr>
            <a:lvl2pPr marL="376733" indent="0">
              <a:buNone/>
              <a:defRPr sz="2307"/>
            </a:lvl2pPr>
            <a:lvl3pPr marL="753466" indent="0">
              <a:buNone/>
              <a:defRPr sz="1978"/>
            </a:lvl3pPr>
            <a:lvl4pPr marL="1130198" indent="0">
              <a:buNone/>
              <a:defRPr sz="1648"/>
            </a:lvl4pPr>
            <a:lvl5pPr marL="1506931" indent="0">
              <a:buNone/>
              <a:defRPr sz="1648"/>
            </a:lvl5pPr>
            <a:lvl6pPr marL="1883664" indent="0">
              <a:buNone/>
              <a:defRPr sz="1648"/>
            </a:lvl6pPr>
            <a:lvl7pPr marL="2260397" indent="0">
              <a:buNone/>
              <a:defRPr sz="1648"/>
            </a:lvl7pPr>
            <a:lvl8pPr marL="2637130" indent="0">
              <a:buNone/>
              <a:defRPr sz="1648"/>
            </a:lvl8pPr>
            <a:lvl9pPr marL="3013862" indent="0">
              <a:buNone/>
              <a:defRPr sz="164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8963" y="3193257"/>
            <a:ext cx="2430000" cy="5915902"/>
          </a:xfrm>
        </p:spPr>
        <p:txBody>
          <a:bodyPr/>
          <a:lstStyle>
            <a:lvl1pPr marL="0" indent="0">
              <a:buNone/>
              <a:defRPr sz="1318"/>
            </a:lvl1pPr>
            <a:lvl2pPr marL="376733" indent="0">
              <a:buNone/>
              <a:defRPr sz="1154"/>
            </a:lvl2pPr>
            <a:lvl3pPr marL="753466" indent="0">
              <a:buNone/>
              <a:defRPr sz="989"/>
            </a:lvl3pPr>
            <a:lvl4pPr marL="1130198" indent="0">
              <a:buNone/>
              <a:defRPr sz="824"/>
            </a:lvl4pPr>
            <a:lvl5pPr marL="1506931" indent="0">
              <a:buNone/>
              <a:defRPr sz="824"/>
            </a:lvl5pPr>
            <a:lvl6pPr marL="1883664" indent="0">
              <a:buNone/>
              <a:defRPr sz="824"/>
            </a:lvl6pPr>
            <a:lvl7pPr marL="2260397" indent="0">
              <a:buNone/>
              <a:defRPr sz="824"/>
            </a:lvl7pPr>
            <a:lvl8pPr marL="2637130" indent="0">
              <a:buNone/>
              <a:defRPr sz="824"/>
            </a:lvl8pPr>
            <a:lvl9pPr marL="3013862" indent="0">
              <a:buNone/>
              <a:defRPr sz="82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82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7982" y="566707"/>
            <a:ext cx="6498312" cy="2057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982" y="2833522"/>
            <a:ext cx="6498312" cy="67536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7981" y="9865588"/>
            <a:ext cx="1695212" cy="5667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5A5C58-6D0E-4CB8-834E-C79CEFD02CB5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5729" y="9865588"/>
            <a:ext cx="2542818" cy="5667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21082" y="9865588"/>
            <a:ext cx="1695212" cy="5667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888DB-95FB-4872-A5DD-0DD704661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500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3466" rtl="0" eaLnBrk="1" latinLnBrk="0" hangingPunct="1">
        <a:lnSpc>
          <a:spcPct val="90000"/>
        </a:lnSpc>
        <a:spcBef>
          <a:spcPct val="0"/>
        </a:spcBef>
        <a:buNone/>
        <a:defRPr sz="362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366" indent="-188366" algn="l" defTabSz="753466" rtl="0" eaLnBrk="1" latinLnBrk="0" hangingPunct="1">
        <a:lnSpc>
          <a:spcPct val="90000"/>
        </a:lnSpc>
        <a:spcBef>
          <a:spcPts val="824"/>
        </a:spcBef>
        <a:buFont typeface="Arial" panose="020B0604020202020204" pitchFamily="34" charset="0"/>
        <a:buChar char="•"/>
        <a:defRPr sz="2307" kern="1200">
          <a:solidFill>
            <a:schemeClr val="tx1"/>
          </a:solidFill>
          <a:latin typeface="+mn-lt"/>
          <a:ea typeface="+mn-ea"/>
          <a:cs typeface="+mn-cs"/>
        </a:defRPr>
      </a:lvl1pPr>
      <a:lvl2pPr marL="565099" indent="-188366" algn="l" defTabSz="753466" rtl="0" eaLnBrk="1" latinLnBrk="0" hangingPunct="1">
        <a:lnSpc>
          <a:spcPct val="90000"/>
        </a:lnSpc>
        <a:spcBef>
          <a:spcPts val="412"/>
        </a:spcBef>
        <a:buFont typeface="Arial" panose="020B0604020202020204" pitchFamily="34" charset="0"/>
        <a:buChar char="•"/>
        <a:defRPr sz="1978" kern="1200">
          <a:solidFill>
            <a:schemeClr val="tx1"/>
          </a:solidFill>
          <a:latin typeface="+mn-lt"/>
          <a:ea typeface="+mn-ea"/>
          <a:cs typeface="+mn-cs"/>
        </a:defRPr>
      </a:lvl2pPr>
      <a:lvl3pPr marL="941832" indent="-188366" algn="l" defTabSz="753466" rtl="0" eaLnBrk="1" latinLnBrk="0" hangingPunct="1">
        <a:lnSpc>
          <a:spcPct val="90000"/>
        </a:lnSpc>
        <a:spcBef>
          <a:spcPts val="412"/>
        </a:spcBef>
        <a:buFont typeface="Arial" panose="020B0604020202020204" pitchFamily="34" charset="0"/>
        <a:buChar char="•"/>
        <a:defRPr sz="1648" kern="1200">
          <a:solidFill>
            <a:schemeClr val="tx1"/>
          </a:solidFill>
          <a:latin typeface="+mn-lt"/>
          <a:ea typeface="+mn-ea"/>
          <a:cs typeface="+mn-cs"/>
        </a:defRPr>
      </a:lvl3pPr>
      <a:lvl4pPr marL="1318565" indent="-188366" algn="l" defTabSz="753466" rtl="0" eaLnBrk="1" latinLnBrk="0" hangingPunct="1">
        <a:lnSpc>
          <a:spcPct val="90000"/>
        </a:lnSpc>
        <a:spcBef>
          <a:spcPts val="412"/>
        </a:spcBef>
        <a:buFont typeface="Arial" panose="020B0604020202020204" pitchFamily="34" charset="0"/>
        <a:buChar char="•"/>
        <a:defRPr sz="1483" kern="1200">
          <a:solidFill>
            <a:schemeClr val="tx1"/>
          </a:solidFill>
          <a:latin typeface="+mn-lt"/>
          <a:ea typeface="+mn-ea"/>
          <a:cs typeface="+mn-cs"/>
        </a:defRPr>
      </a:lvl4pPr>
      <a:lvl5pPr marL="1695298" indent="-188366" algn="l" defTabSz="753466" rtl="0" eaLnBrk="1" latinLnBrk="0" hangingPunct="1">
        <a:lnSpc>
          <a:spcPct val="90000"/>
        </a:lnSpc>
        <a:spcBef>
          <a:spcPts val="412"/>
        </a:spcBef>
        <a:buFont typeface="Arial" panose="020B0604020202020204" pitchFamily="34" charset="0"/>
        <a:buChar char="•"/>
        <a:defRPr sz="1483" kern="1200">
          <a:solidFill>
            <a:schemeClr val="tx1"/>
          </a:solidFill>
          <a:latin typeface="+mn-lt"/>
          <a:ea typeface="+mn-ea"/>
          <a:cs typeface="+mn-cs"/>
        </a:defRPr>
      </a:lvl5pPr>
      <a:lvl6pPr marL="2072030" indent="-188366" algn="l" defTabSz="753466" rtl="0" eaLnBrk="1" latinLnBrk="0" hangingPunct="1">
        <a:lnSpc>
          <a:spcPct val="90000"/>
        </a:lnSpc>
        <a:spcBef>
          <a:spcPts val="412"/>
        </a:spcBef>
        <a:buFont typeface="Arial" panose="020B0604020202020204" pitchFamily="34" charset="0"/>
        <a:buChar char="•"/>
        <a:defRPr sz="1483" kern="1200">
          <a:solidFill>
            <a:schemeClr val="tx1"/>
          </a:solidFill>
          <a:latin typeface="+mn-lt"/>
          <a:ea typeface="+mn-ea"/>
          <a:cs typeface="+mn-cs"/>
        </a:defRPr>
      </a:lvl6pPr>
      <a:lvl7pPr marL="2448763" indent="-188366" algn="l" defTabSz="753466" rtl="0" eaLnBrk="1" latinLnBrk="0" hangingPunct="1">
        <a:lnSpc>
          <a:spcPct val="90000"/>
        </a:lnSpc>
        <a:spcBef>
          <a:spcPts val="412"/>
        </a:spcBef>
        <a:buFont typeface="Arial" panose="020B0604020202020204" pitchFamily="34" charset="0"/>
        <a:buChar char="•"/>
        <a:defRPr sz="1483" kern="1200">
          <a:solidFill>
            <a:schemeClr val="tx1"/>
          </a:solidFill>
          <a:latin typeface="+mn-lt"/>
          <a:ea typeface="+mn-ea"/>
          <a:cs typeface="+mn-cs"/>
        </a:defRPr>
      </a:lvl7pPr>
      <a:lvl8pPr marL="2825496" indent="-188366" algn="l" defTabSz="753466" rtl="0" eaLnBrk="1" latinLnBrk="0" hangingPunct="1">
        <a:lnSpc>
          <a:spcPct val="90000"/>
        </a:lnSpc>
        <a:spcBef>
          <a:spcPts val="412"/>
        </a:spcBef>
        <a:buFont typeface="Arial" panose="020B0604020202020204" pitchFamily="34" charset="0"/>
        <a:buChar char="•"/>
        <a:defRPr sz="1483" kern="1200">
          <a:solidFill>
            <a:schemeClr val="tx1"/>
          </a:solidFill>
          <a:latin typeface="+mn-lt"/>
          <a:ea typeface="+mn-ea"/>
          <a:cs typeface="+mn-cs"/>
        </a:defRPr>
      </a:lvl8pPr>
      <a:lvl9pPr marL="3202229" indent="-188366" algn="l" defTabSz="753466" rtl="0" eaLnBrk="1" latinLnBrk="0" hangingPunct="1">
        <a:lnSpc>
          <a:spcPct val="90000"/>
        </a:lnSpc>
        <a:spcBef>
          <a:spcPts val="412"/>
        </a:spcBef>
        <a:buFont typeface="Arial" panose="020B0604020202020204" pitchFamily="34" charset="0"/>
        <a:buChar char="•"/>
        <a:defRPr sz="148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3466" rtl="0" eaLnBrk="1" latinLnBrk="0" hangingPunct="1">
        <a:defRPr sz="1483" kern="1200">
          <a:solidFill>
            <a:schemeClr val="tx1"/>
          </a:solidFill>
          <a:latin typeface="+mn-lt"/>
          <a:ea typeface="+mn-ea"/>
          <a:cs typeface="+mn-cs"/>
        </a:defRPr>
      </a:lvl1pPr>
      <a:lvl2pPr marL="376733" algn="l" defTabSz="753466" rtl="0" eaLnBrk="1" latinLnBrk="0" hangingPunct="1">
        <a:defRPr sz="1483" kern="1200">
          <a:solidFill>
            <a:schemeClr val="tx1"/>
          </a:solidFill>
          <a:latin typeface="+mn-lt"/>
          <a:ea typeface="+mn-ea"/>
          <a:cs typeface="+mn-cs"/>
        </a:defRPr>
      </a:lvl2pPr>
      <a:lvl3pPr marL="753466" algn="l" defTabSz="753466" rtl="0" eaLnBrk="1" latinLnBrk="0" hangingPunct="1">
        <a:defRPr sz="1483" kern="1200">
          <a:solidFill>
            <a:schemeClr val="tx1"/>
          </a:solidFill>
          <a:latin typeface="+mn-lt"/>
          <a:ea typeface="+mn-ea"/>
          <a:cs typeface="+mn-cs"/>
        </a:defRPr>
      </a:lvl3pPr>
      <a:lvl4pPr marL="1130198" algn="l" defTabSz="753466" rtl="0" eaLnBrk="1" latinLnBrk="0" hangingPunct="1">
        <a:defRPr sz="1483" kern="1200">
          <a:solidFill>
            <a:schemeClr val="tx1"/>
          </a:solidFill>
          <a:latin typeface="+mn-lt"/>
          <a:ea typeface="+mn-ea"/>
          <a:cs typeface="+mn-cs"/>
        </a:defRPr>
      </a:lvl4pPr>
      <a:lvl5pPr marL="1506931" algn="l" defTabSz="753466" rtl="0" eaLnBrk="1" latinLnBrk="0" hangingPunct="1">
        <a:defRPr sz="1483" kern="1200">
          <a:solidFill>
            <a:schemeClr val="tx1"/>
          </a:solidFill>
          <a:latin typeface="+mn-lt"/>
          <a:ea typeface="+mn-ea"/>
          <a:cs typeface="+mn-cs"/>
        </a:defRPr>
      </a:lvl5pPr>
      <a:lvl6pPr marL="1883664" algn="l" defTabSz="753466" rtl="0" eaLnBrk="1" latinLnBrk="0" hangingPunct="1">
        <a:defRPr sz="1483" kern="1200">
          <a:solidFill>
            <a:schemeClr val="tx1"/>
          </a:solidFill>
          <a:latin typeface="+mn-lt"/>
          <a:ea typeface="+mn-ea"/>
          <a:cs typeface="+mn-cs"/>
        </a:defRPr>
      </a:lvl6pPr>
      <a:lvl7pPr marL="2260397" algn="l" defTabSz="753466" rtl="0" eaLnBrk="1" latinLnBrk="0" hangingPunct="1">
        <a:defRPr sz="1483" kern="1200">
          <a:solidFill>
            <a:schemeClr val="tx1"/>
          </a:solidFill>
          <a:latin typeface="+mn-lt"/>
          <a:ea typeface="+mn-ea"/>
          <a:cs typeface="+mn-cs"/>
        </a:defRPr>
      </a:lvl7pPr>
      <a:lvl8pPr marL="2637130" algn="l" defTabSz="753466" rtl="0" eaLnBrk="1" latinLnBrk="0" hangingPunct="1">
        <a:defRPr sz="1483" kern="1200">
          <a:solidFill>
            <a:schemeClr val="tx1"/>
          </a:solidFill>
          <a:latin typeface="+mn-lt"/>
          <a:ea typeface="+mn-ea"/>
          <a:cs typeface="+mn-cs"/>
        </a:defRPr>
      </a:lvl8pPr>
      <a:lvl9pPr marL="3013862" algn="l" defTabSz="753466" rtl="0" eaLnBrk="1" latinLnBrk="0" hangingPunct="1">
        <a:defRPr sz="148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C9A0BE9E-36D7-414C-A0DE-D5F2204104E3}"/>
              </a:ext>
            </a:extLst>
          </p:cNvPr>
          <p:cNvSpPr txBox="1"/>
          <p:nvPr/>
        </p:nvSpPr>
        <p:spPr>
          <a:xfrm>
            <a:off x="302498" y="9882161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1</a:t>
            </a:r>
          </a:p>
        </p:txBody>
      </p:sp>
      <p:pic>
        <p:nvPicPr>
          <p:cNvPr id="87" name="Picture 86">
            <a:extLst>
              <a:ext uri="{FF2B5EF4-FFF2-40B4-BE49-F238E27FC236}">
                <a16:creationId xmlns:a16="http://schemas.microsoft.com/office/drawing/2014/main" id="{7226FA10-FBB9-498B-8D89-DA6CC64A57AC}"/>
              </a:ext>
            </a:extLst>
          </p:cNvPr>
          <p:cNvPicPr/>
          <p:nvPr/>
        </p:nvPicPr>
        <p:blipFill rotWithShape="1">
          <a:blip r:embed="rId2"/>
          <a:srcRect t="10233" r="38636"/>
          <a:stretch/>
        </p:blipFill>
        <p:spPr bwMode="auto">
          <a:xfrm>
            <a:off x="475830" y="5190282"/>
            <a:ext cx="5772306" cy="4501177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88" name="TextBox 87">
            <a:extLst>
              <a:ext uri="{FF2B5EF4-FFF2-40B4-BE49-F238E27FC236}">
                <a16:creationId xmlns:a16="http://schemas.microsoft.com/office/drawing/2014/main" id="{F98F0013-4EB8-4000-B362-43AD244B3BA7}"/>
              </a:ext>
            </a:extLst>
          </p:cNvPr>
          <p:cNvSpPr txBox="1"/>
          <p:nvPr/>
        </p:nvSpPr>
        <p:spPr>
          <a:xfrm>
            <a:off x="1679474" y="58339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1F67EF9-C4F5-4D01-A744-1DFEAAFD8A65}"/>
              </a:ext>
            </a:extLst>
          </p:cNvPr>
          <p:cNvSpPr txBox="1"/>
          <p:nvPr/>
        </p:nvSpPr>
        <p:spPr>
          <a:xfrm>
            <a:off x="839300" y="475206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90" name="Group 89">
            <a:extLst>
              <a:ext uri="{FF2B5EF4-FFF2-40B4-BE49-F238E27FC236}">
                <a16:creationId xmlns:a16="http://schemas.microsoft.com/office/drawing/2014/main" id="{722A46A9-E46A-47FB-B437-DFEBDA6CD910}"/>
              </a:ext>
            </a:extLst>
          </p:cNvPr>
          <p:cNvGrpSpPr/>
          <p:nvPr/>
        </p:nvGrpSpPr>
        <p:grpSpPr>
          <a:xfrm>
            <a:off x="1513791" y="308753"/>
            <a:ext cx="3700129" cy="4306186"/>
            <a:chOff x="1158950" y="903767"/>
            <a:chExt cx="3700129" cy="4306186"/>
          </a:xfrm>
        </p:grpSpPr>
        <p:pic>
          <p:nvPicPr>
            <p:cNvPr id="91" name="Picture 90">
              <a:extLst>
                <a:ext uri="{FF2B5EF4-FFF2-40B4-BE49-F238E27FC236}">
                  <a16:creationId xmlns:a16="http://schemas.microsoft.com/office/drawing/2014/main" id="{B9B18F48-157E-4D3B-A747-79B24FDF31FC}"/>
                </a:ext>
              </a:extLst>
            </p:cNvPr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4362"/>
            <a:stretch/>
          </p:blipFill>
          <p:spPr bwMode="auto">
            <a:xfrm>
              <a:off x="1158950" y="903767"/>
              <a:ext cx="3700129" cy="4306186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EE6BD884-383C-47F7-BE39-6DDF164C3C2E}"/>
                </a:ext>
              </a:extLst>
            </p:cNvPr>
            <p:cNvSpPr/>
            <p:nvPr/>
          </p:nvSpPr>
          <p:spPr>
            <a:xfrm>
              <a:off x="2495550" y="4610100"/>
              <a:ext cx="1666875" cy="3714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Wavelength (nm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557992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C9A0BE9E-36D7-414C-A0DE-D5F2204104E3}"/>
              </a:ext>
            </a:extLst>
          </p:cNvPr>
          <p:cNvSpPr txBox="1"/>
          <p:nvPr/>
        </p:nvSpPr>
        <p:spPr>
          <a:xfrm>
            <a:off x="302498" y="9882161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D0BB690-0632-4EA8-8C4F-A069FA2EBE7D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498" y="989938"/>
            <a:ext cx="6903520" cy="2381059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1B89204-AD0E-4A64-94B5-196C49794F4D}"/>
              </a:ext>
            </a:extLst>
          </p:cNvPr>
          <p:cNvSpPr txBox="1"/>
          <p:nvPr/>
        </p:nvSpPr>
        <p:spPr>
          <a:xfrm>
            <a:off x="604152" y="62060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22AE998-25B0-4855-B88F-C3D6EC851A3B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8963" y="4512808"/>
            <a:ext cx="6177515" cy="3264194"/>
          </a:xfrm>
          <a:prstGeom prst="rect">
            <a:avLst/>
          </a:prstGeom>
          <a:noFill/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3EDA4B-1D86-4854-920F-25D3DD734DC3}"/>
              </a:ext>
            </a:extLst>
          </p:cNvPr>
          <p:cNvSpPr txBox="1"/>
          <p:nvPr/>
        </p:nvSpPr>
        <p:spPr>
          <a:xfrm>
            <a:off x="290252" y="399461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200980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C9A0BE9E-36D7-414C-A0DE-D5F2204104E3}"/>
              </a:ext>
            </a:extLst>
          </p:cNvPr>
          <p:cNvSpPr txBox="1"/>
          <p:nvPr/>
        </p:nvSpPr>
        <p:spPr>
          <a:xfrm>
            <a:off x="302498" y="9882161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75B0084-7A9A-4ECF-A27C-B7FAA8E220ED}"/>
              </a:ext>
            </a:extLst>
          </p:cNvPr>
          <p:cNvSpPr txBox="1"/>
          <p:nvPr/>
        </p:nvSpPr>
        <p:spPr>
          <a:xfrm>
            <a:off x="125074" y="55284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446410D-6DBD-421D-AB65-1BB9613956D4}"/>
              </a:ext>
            </a:extLst>
          </p:cNvPr>
          <p:cNvPicPr/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2652" b="2768"/>
          <a:stretch/>
        </p:blipFill>
        <p:spPr bwMode="auto">
          <a:xfrm>
            <a:off x="217104" y="983982"/>
            <a:ext cx="7176976" cy="431681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F90DB0F-9A62-4688-AD88-90DAC075AB4E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0666" y="6217502"/>
            <a:ext cx="5336858" cy="3059837"/>
          </a:xfrm>
          <a:prstGeom prst="rect">
            <a:avLst/>
          </a:prstGeom>
          <a:noFill/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01FD79C-3874-4260-82EA-DFD0A59FDB43}"/>
              </a:ext>
            </a:extLst>
          </p:cNvPr>
          <p:cNvSpPr txBox="1"/>
          <p:nvPr/>
        </p:nvSpPr>
        <p:spPr>
          <a:xfrm>
            <a:off x="950665" y="5614252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76BACCD-0B93-4523-A316-9F85CA71DFF1}"/>
              </a:ext>
            </a:extLst>
          </p:cNvPr>
          <p:cNvSpPr/>
          <p:nvPr/>
        </p:nvSpPr>
        <p:spPr>
          <a:xfrm>
            <a:off x="3348252" y="9066663"/>
            <a:ext cx="577755" cy="1137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00" dirty="0">
                <a:solidFill>
                  <a:schemeClr val="tx1"/>
                </a:solidFill>
                <a:latin typeface="Arial Narrow" panose="020B0606020202030204" pitchFamily="34" charset="0"/>
              </a:rPr>
              <a:t>FL1-H : FL1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6DF4983-A69E-434C-A5F4-3B99D50C594C}"/>
              </a:ext>
            </a:extLst>
          </p:cNvPr>
          <p:cNvSpPr/>
          <p:nvPr/>
        </p:nvSpPr>
        <p:spPr>
          <a:xfrm>
            <a:off x="5120186" y="9068937"/>
            <a:ext cx="577755" cy="1137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00" dirty="0">
                <a:solidFill>
                  <a:schemeClr val="tx1"/>
                </a:solidFill>
                <a:latin typeface="Arial Narrow" panose="020B0606020202030204" pitchFamily="34" charset="0"/>
              </a:rPr>
              <a:t>FL1-H : FL1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5DE01A4-90FD-4F54-A57B-F9DDEA5D4B4E}"/>
              </a:ext>
            </a:extLst>
          </p:cNvPr>
          <p:cNvSpPr/>
          <p:nvPr/>
        </p:nvSpPr>
        <p:spPr>
          <a:xfrm>
            <a:off x="1576318" y="9009797"/>
            <a:ext cx="577755" cy="1137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00" dirty="0">
                <a:solidFill>
                  <a:schemeClr val="tx1"/>
                </a:solidFill>
                <a:latin typeface="Arial Narrow" panose="020B0606020202030204" pitchFamily="34" charset="0"/>
              </a:rPr>
              <a:t>FL1-H : FL1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8F312DB-5285-456D-BCEB-60D81F975BE2}"/>
              </a:ext>
            </a:extLst>
          </p:cNvPr>
          <p:cNvSpPr/>
          <p:nvPr/>
        </p:nvSpPr>
        <p:spPr>
          <a:xfrm>
            <a:off x="1576317" y="7602171"/>
            <a:ext cx="577755" cy="1137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00" dirty="0">
                <a:solidFill>
                  <a:schemeClr val="tx1"/>
                </a:solidFill>
                <a:latin typeface="Arial Narrow" panose="020B0606020202030204" pitchFamily="34" charset="0"/>
              </a:rPr>
              <a:t>FL1-H : FL1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F249327-3002-4FDF-B78F-7D61D5646C84}"/>
              </a:ext>
            </a:extLst>
          </p:cNvPr>
          <p:cNvSpPr/>
          <p:nvPr/>
        </p:nvSpPr>
        <p:spPr>
          <a:xfrm>
            <a:off x="3320958" y="7602171"/>
            <a:ext cx="577755" cy="1137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00" dirty="0">
                <a:solidFill>
                  <a:schemeClr val="tx1"/>
                </a:solidFill>
                <a:latin typeface="Arial Narrow" panose="020B0606020202030204" pitchFamily="34" charset="0"/>
              </a:rPr>
              <a:t>FL1-H : FL1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AC4E301-4DA3-4E43-82C4-0BBA6DA0D4D9}"/>
              </a:ext>
            </a:extLst>
          </p:cNvPr>
          <p:cNvSpPr/>
          <p:nvPr/>
        </p:nvSpPr>
        <p:spPr>
          <a:xfrm>
            <a:off x="5120188" y="7633689"/>
            <a:ext cx="577755" cy="1137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00" dirty="0">
                <a:solidFill>
                  <a:schemeClr val="tx1"/>
                </a:solidFill>
                <a:latin typeface="Arial Narrow" panose="020B0606020202030204" pitchFamily="34" charset="0"/>
              </a:rPr>
              <a:t>FL1-H : FL1</a:t>
            </a:r>
          </a:p>
        </p:txBody>
      </p:sp>
    </p:spTree>
    <p:extLst>
      <p:ext uri="{BB962C8B-B14F-4D97-AF65-F5344CB8AC3E}">
        <p14:creationId xmlns:p14="http://schemas.microsoft.com/office/powerpoint/2010/main" val="21912839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C9A0BE9E-36D7-414C-A0DE-D5F2204104E3}"/>
              </a:ext>
            </a:extLst>
          </p:cNvPr>
          <p:cNvSpPr txBox="1"/>
          <p:nvPr/>
        </p:nvSpPr>
        <p:spPr>
          <a:xfrm>
            <a:off x="302498" y="9882161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91217C6-3F9E-48BD-AE42-98817597909B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6796" y="2178279"/>
            <a:ext cx="3768098" cy="2808391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C05A559-6EB2-4C9B-AEAB-007621BDDC30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2754" y="6270426"/>
            <a:ext cx="4388765" cy="324040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7E5D079-B66D-4671-AFB1-B1CF47AF4C95}"/>
              </a:ext>
            </a:extLst>
          </p:cNvPr>
          <p:cNvSpPr txBox="1"/>
          <p:nvPr/>
        </p:nvSpPr>
        <p:spPr>
          <a:xfrm>
            <a:off x="1018242" y="1265274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2452AA8-AA53-4C57-BC59-67E0720B3D44}"/>
              </a:ext>
            </a:extLst>
          </p:cNvPr>
          <p:cNvSpPr txBox="1"/>
          <p:nvPr/>
        </p:nvSpPr>
        <p:spPr>
          <a:xfrm>
            <a:off x="1247024" y="553034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27587458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42</Words>
  <Application>Microsoft Office PowerPoint</Application>
  <PresentationFormat>Custom</PresentationFormat>
  <Paragraphs>1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Arial Narrow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 Wang</dc:creator>
  <cp:lastModifiedBy>Mu Wang</cp:lastModifiedBy>
  <cp:revision>9</cp:revision>
  <dcterms:created xsi:type="dcterms:W3CDTF">2023-08-01T00:41:27Z</dcterms:created>
  <dcterms:modified xsi:type="dcterms:W3CDTF">2023-08-01T01:26:06Z</dcterms:modified>
</cp:coreProperties>
</file>